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84" y="1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B8F01C-AA43-4FF1-1A0C-A9F19943A6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BCA89B8-773F-DF17-3810-90836A751E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3AD68C-3CBB-C64A-C3F4-F10D6B600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396A93-D384-ECFA-0638-4774139FF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569B0E-6499-A280-2904-FBA825B24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6364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0D88CB-B1FE-D949-837C-F1C50B043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BAB680E-A944-EB68-07FB-27777D36E9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DF2366-B0EE-97AF-2DCE-EB560B154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22E6BD-DF9B-30AC-DB38-88BCA6BE9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20FB0D-810A-B942-9237-374B01AE2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7235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D23F597-52EB-8FA2-7047-D27CC7EC00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ED8FCA2-E44F-3494-2774-DA0710DFA1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7E9A22-8D7B-126C-9F7D-3D9C8CCB6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57C6394-146C-1AAF-75E7-9EA3726F3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39D9E5-2E5F-7EB3-4C5C-556395EDD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2581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84FB20-AB5E-6368-70F4-B0259F0E15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D46FA3-F165-B1C7-CB60-E9E95F7890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14CA85-EE96-6127-1C90-EAB21D3DC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43524C-6528-32F3-0153-D05C09506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FA4010-1B0E-F481-A848-05A2D1901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4780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27DE21-E3A9-4B3F-D5C1-5BC8CC85F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532F035-1537-375F-04A1-52A8A5D94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3880BA-5B1B-84EE-F866-50BF98966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6DC85B-DA13-0CE1-B256-C87DAFBE7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00C6BC-ECF8-2C1B-8868-920E840CE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87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E639E9-7102-EAA4-4ADC-9D3233470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8630D5-A9F4-8529-69E1-86193EBEAF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08AA21-8818-4D1C-3AE8-A002BA2521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431412-248B-62AE-09A0-1974C310A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DD6C6D-CAD4-1522-717D-025DFDEC5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CEBA9B-A83D-4F44-FE08-732821F3F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0931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02A173-2310-F31B-FCBC-BAE775944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EBF162-0EAB-1163-F2D5-22311EE50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4A1147-3C4D-13C3-23D4-9BB13FA65B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DE5651-E057-CA0F-4070-25D383B17B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7092421-9CB7-36A8-F7AC-C34E6F314C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D86DC88-1F6B-7B17-9422-81F31C995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05FBB23-8DFE-E578-84BC-3ED128A18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4C52D10-7FC4-45A7-2DC3-154C0298C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572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3EA96C-EF3B-8F01-2F60-49484BDBC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894EF81-B787-F584-D79A-313DD89D4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F4DCD26-4A91-B616-0EB7-C43142C9D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3746A43-2DE3-F07D-E0EF-E656E0C39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2512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2C0BE90-E74E-C965-6817-5DE298974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0DC38AA-963D-2F1A-5993-367D58263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21C45B4-D2D5-B442-C6DB-514D0C741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3610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C51E87-9CB5-E56E-FD7C-8526EAF6FD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F1BB2A-D893-B99F-8650-CDBF7FBFF1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0341EC-58C9-6AB2-396D-11DFD1143F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883EF3-8EE3-E1BA-BAD5-0673225E9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6E6A3A-F015-0967-7C63-B147DB3FE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4101D9-F805-CC10-464E-151523A21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096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8847DC-42E6-D503-33C6-25E5E128D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A744F03-9028-A016-B915-A73AB78813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7DD077E-75F5-D1F5-BC10-919BE95AAA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A651010-3723-13D6-5CE0-9330B187D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416E72A-D0E1-68CF-5651-2934B718F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8794472-A3CE-563F-7B78-A3BEC6298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945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E188249-A78D-DB10-03D4-B0D20908A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7BC0B1-E599-762A-B45D-64F60516A8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880297-8F04-22FA-864B-13CC2DDC4C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FCB04-953A-4F03-9571-F301F0CB6D9C}" type="datetimeFigureOut">
              <a:rPr lang="zh-CN" altLang="en-US" smtClean="0"/>
              <a:t>2023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70E5D9-A2B4-3236-8A11-E8E1B0D883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96B9CE-7FDD-9CE1-B08C-69831327E3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2F8987-073C-49A9-A917-9D377ECB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5176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3" Type="http://schemas.openxmlformats.org/officeDocument/2006/relationships/image" Target="../media/image2.tif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1B545D41-CA86-B60E-EF57-19E8BB39AEE8}"/>
              </a:ext>
            </a:extLst>
          </p:cNvPr>
          <p:cNvSpPr/>
          <p:nvPr/>
        </p:nvSpPr>
        <p:spPr>
          <a:xfrm>
            <a:off x="1103053" y="5857726"/>
            <a:ext cx="9882973" cy="100027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spcBef>
                <a:spcPts val="600"/>
              </a:spcBef>
              <a:spcAft>
                <a:spcPts val="60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b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US" altLang="zh-CN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zh-CN" altLang="zh-CN" sz="1800" kern="100">
                <a:effectLst/>
                <a:latin typeface="等线" panose="02010600030101010101" pitchFamily="2" charset="-122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kern="100">
                <a:effectLst/>
                <a:latin typeface="等线" panose="02010600030101010101" pitchFamily="2" charset="-122"/>
                <a:ea typeface="Times New Roman" panose="02020603050405020304" pitchFamily="18" charset="0"/>
                <a:cs typeface="Times New Roman" panose="02020603050405020304" pitchFamily="18" charset="0"/>
              </a:rPr>
              <a:t>qRT-PCR validation of differentially expressed genes in RNA-seq. Relationship between relative change of gene expression measured by qRT-PCR and transcriptome sequencing. </a:t>
            </a:r>
            <a:endParaRPr lang="zh-CN" altLang="zh-CN" sz="2400" kern="10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19ED059B-0DCB-3D4D-5561-EC80C0670D1C}"/>
              </a:ext>
            </a:extLst>
          </p:cNvPr>
          <p:cNvGrpSpPr/>
          <p:nvPr/>
        </p:nvGrpSpPr>
        <p:grpSpPr>
          <a:xfrm>
            <a:off x="1645837" y="-5938"/>
            <a:ext cx="8811215" cy="5813169"/>
            <a:chOff x="1645837" y="-5938"/>
            <a:chExt cx="8811215" cy="5813169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C9D40086-FA8C-F582-3CF2-6B0D9C2943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1271" y="0"/>
              <a:ext cx="1757028" cy="1442852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212F3F09-CF9C-ADEA-E7BC-810C32BB970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8299" y="1"/>
              <a:ext cx="1753534" cy="1442852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BA6729CB-9754-A227-9E31-10DD81D5988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7771" y="0"/>
              <a:ext cx="1754038" cy="1442852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E472857B-DAFA-42A3-05B4-F22B5EF5D5F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0737" y="-1"/>
              <a:ext cx="1750040" cy="1442852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A81F5A0-F4D1-140C-70D8-D512CD3B6EF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86715" y="-5938"/>
              <a:ext cx="1750040" cy="1442852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C42A5808-0825-AFAC-FCEF-F8FF8352064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5837" y="1454728"/>
              <a:ext cx="1753534" cy="1442853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5EFE0550-995F-73AD-0FA8-F876BDFE6F5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8298" y="1460602"/>
              <a:ext cx="1753535" cy="143698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12206E5C-6444-36BC-9E2C-917881F9DCD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5645" y="1454664"/>
              <a:ext cx="1754038" cy="1436980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86C5E59D-88F8-ABD7-4B8C-EA870699AC3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98083" y="1460600"/>
              <a:ext cx="1738672" cy="1425104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1235BEC5-7894-5C63-A77B-534872AAEC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5837" y="2909457"/>
              <a:ext cx="1753534" cy="1436980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1906CD3A-7D41-4D65-7AF7-574133F7BF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8297" y="2915331"/>
              <a:ext cx="1753536" cy="1430977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6E16B11B-BFD8-6E68-B953-FA500C415E6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5645" y="2909324"/>
              <a:ext cx="1743215" cy="1430977"/>
            </a:xfrm>
            <a:prstGeom prst="rect">
              <a:avLst/>
            </a:prstGeom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D9A213C6-B313-6FC6-572A-B04D1BECAA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7562" y="2915197"/>
              <a:ext cx="1743215" cy="1425103"/>
            </a:xfrm>
            <a:prstGeom prst="rect">
              <a:avLst/>
            </a:prstGeom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7926E9B0-B96E-A146-D16E-482C411447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93194" y="2909324"/>
              <a:ext cx="1750040" cy="1430976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A40FC967-1517-2480-C52B-C4AD875711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5837" y="4364313"/>
              <a:ext cx="1753534" cy="1436980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CAA24280-BABB-EDA4-5CB0-2292E7C3BD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8297" y="4364313"/>
              <a:ext cx="1753534" cy="1436980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EEE6C659-D3FD-9625-578E-FADC6EFCA14E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5645" y="4364057"/>
              <a:ext cx="1746164" cy="1430977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BB3EC6C1-FC0A-7749-65D8-5067631B79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4614" y="4363853"/>
              <a:ext cx="1746163" cy="1443378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66E56DFA-2C5E-E0BF-8F3E-CD9E008ADE91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80778" y="4381995"/>
              <a:ext cx="1776274" cy="1424909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9AC60395-30D2-3B7E-8185-AF5A612DE0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44045" y="1460275"/>
              <a:ext cx="1751232" cy="142542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49952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27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n yang</dc:creator>
  <cp:lastModifiedBy>han yang</cp:lastModifiedBy>
  <cp:revision>10</cp:revision>
  <dcterms:created xsi:type="dcterms:W3CDTF">2023-08-16T06:41:10Z</dcterms:created>
  <dcterms:modified xsi:type="dcterms:W3CDTF">2023-09-06T09:02:36Z</dcterms:modified>
</cp:coreProperties>
</file>